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500" autoAdjust="0"/>
    <p:restoredTop sz="94660"/>
  </p:normalViewPr>
  <p:slideViewPr>
    <p:cSldViewPr snapToGrid="0">
      <p:cViewPr>
        <p:scale>
          <a:sx n="30" d="100"/>
          <a:sy n="30" d="100"/>
        </p:scale>
        <p:origin x="2604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FAF65-69CD-4446-994B-634426D96684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5E1DA-22D6-4C4F-9688-C9627F903B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381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FAF65-69CD-4446-994B-634426D96684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5E1DA-22D6-4C4F-9688-C9627F903B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833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FAF65-69CD-4446-994B-634426D96684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5E1DA-22D6-4C4F-9688-C9627F903B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205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FAF65-69CD-4446-994B-634426D96684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5E1DA-22D6-4C4F-9688-C9627F903B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678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FAF65-69CD-4446-994B-634426D96684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5E1DA-22D6-4C4F-9688-C9627F903B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730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FAF65-69CD-4446-994B-634426D96684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5E1DA-22D6-4C4F-9688-C9627F903B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1444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FAF65-69CD-4446-994B-634426D96684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5E1DA-22D6-4C4F-9688-C9627F903B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6778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FAF65-69CD-4446-994B-634426D96684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5E1DA-22D6-4C4F-9688-C9627F903B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2986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FAF65-69CD-4446-994B-634426D96684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5E1DA-22D6-4C4F-9688-C9627F903B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515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FAF65-69CD-4446-994B-634426D96684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5E1DA-22D6-4C4F-9688-C9627F903B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741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CFAF65-69CD-4446-994B-634426D96684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5E1DA-22D6-4C4F-9688-C9627F903B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574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CFAF65-69CD-4446-994B-634426D96684}" type="datetimeFigureOut">
              <a:rPr lang="en-US" smtClean="0"/>
              <a:t>11/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65E1DA-22D6-4C4F-9688-C9627F903B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302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0" y="0"/>
            <a:ext cx="7311245" cy="20715990"/>
            <a:chOff x="2095803" y="-541420"/>
            <a:chExt cx="7311245" cy="20715990"/>
          </a:xfrm>
        </p:grpSpPr>
        <p:grpSp>
          <p:nvGrpSpPr>
            <p:cNvPr id="6" name="Group 5"/>
            <p:cNvGrpSpPr/>
            <p:nvPr/>
          </p:nvGrpSpPr>
          <p:grpSpPr>
            <a:xfrm>
              <a:off x="2095803" y="-541420"/>
              <a:ext cx="7311245" cy="20715990"/>
              <a:chOff x="2095803" y="-541420"/>
              <a:chExt cx="7311245" cy="20715990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 rotWithShape="1">
              <a:blip r:embed="rId2"/>
              <a:srcRect l="18312" t="13980" r="25688"/>
              <a:stretch/>
            </p:blipFill>
            <p:spPr>
              <a:xfrm>
                <a:off x="2095803" y="-541420"/>
                <a:ext cx="7286192" cy="6292516"/>
              </a:xfrm>
              <a:prstGeom prst="rect">
                <a:avLst/>
              </a:prstGeom>
            </p:spPr>
          </p:pic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3"/>
              <a:srcRect l="18262" t="13913" r="25642"/>
              <a:stretch/>
            </p:blipFill>
            <p:spPr>
              <a:xfrm>
                <a:off x="2095804" y="5650888"/>
                <a:ext cx="7298718" cy="6297461"/>
              </a:xfrm>
              <a:prstGeom prst="rect">
                <a:avLst/>
              </a:prstGeom>
            </p:spPr>
          </p:pic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4"/>
              <a:srcRect l="18263" t="14256" r="25545"/>
              <a:stretch/>
            </p:blipFill>
            <p:spPr>
              <a:xfrm>
                <a:off x="2095804" y="11830670"/>
                <a:ext cx="7311244" cy="6272408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5"/>
              <a:srcRect l="18359" t="44392" r="25641"/>
              <a:stretch/>
            </p:blipFill>
            <p:spPr>
              <a:xfrm>
                <a:off x="2108330" y="16106743"/>
                <a:ext cx="7286192" cy="4067827"/>
              </a:xfrm>
              <a:prstGeom prst="rect">
                <a:avLst/>
              </a:prstGeom>
            </p:spPr>
          </p:pic>
        </p:grpSp>
        <p:sp>
          <p:nvSpPr>
            <p:cNvPr id="8" name="Rectangle 7"/>
            <p:cNvSpPr/>
            <p:nvPr/>
          </p:nvSpPr>
          <p:spPr>
            <a:xfrm>
              <a:off x="7744546" y="4528867"/>
              <a:ext cx="1159292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zcD</a:t>
              </a:r>
              <a:r>
                <a:rPr lang="en-US" sz="11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</a:t>
              </a:r>
              <a:r>
                <a:rPr lang="en-US" sz="11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ssociated</a:t>
              </a:r>
              <a:endParaRPr lang="en-US" sz="1100" b="1" dirty="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4040561" y="5436660"/>
              <a:ext cx="50687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rnR</a:t>
              </a:r>
              <a:endParaRPr lang="en-US" sz="1100" b="1" dirty="0"/>
            </a:p>
          </p:txBody>
        </p:sp>
        <p:cxnSp>
          <p:nvCxnSpPr>
            <p:cNvPr id="11" name="Straight Connector 10"/>
            <p:cNvCxnSpPr/>
            <p:nvPr/>
          </p:nvCxnSpPr>
          <p:spPr>
            <a:xfrm>
              <a:off x="7664121" y="4129088"/>
              <a:ext cx="0" cy="114300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1"/>
            <p:cNvSpPr/>
            <p:nvPr/>
          </p:nvSpPr>
          <p:spPr>
            <a:xfrm>
              <a:off x="7663331" y="8118217"/>
              <a:ext cx="123303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HSA-associated</a:t>
              </a:r>
              <a:endParaRPr lang="en-US" sz="1100" b="1" dirty="0"/>
            </a:p>
          </p:txBody>
        </p:sp>
        <p:cxnSp>
          <p:nvCxnSpPr>
            <p:cNvPr id="13" name="Straight Connector 12"/>
            <p:cNvCxnSpPr/>
            <p:nvPr/>
          </p:nvCxnSpPr>
          <p:spPr>
            <a:xfrm>
              <a:off x="7663331" y="5650888"/>
              <a:ext cx="0" cy="609193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Rectangle 14"/>
            <p:cNvSpPr/>
            <p:nvPr/>
          </p:nvSpPr>
          <p:spPr>
            <a:xfrm>
              <a:off x="4096011" y="5257929"/>
              <a:ext cx="553357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mtR</a:t>
              </a:r>
              <a:endParaRPr lang="en-US" sz="1100" b="1" dirty="0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7743756" y="17269410"/>
              <a:ext cx="105990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rs</a:t>
              </a:r>
              <a:r>
                <a:rPr lang="en-US" sz="11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associated</a:t>
              </a:r>
              <a:endParaRPr lang="en-US" sz="1100" b="1" dirty="0"/>
            </a:p>
          </p:txBody>
        </p:sp>
        <p:cxnSp>
          <p:nvCxnSpPr>
            <p:cNvPr id="18" name="Straight Connector 17"/>
            <p:cNvCxnSpPr/>
            <p:nvPr/>
          </p:nvCxnSpPr>
          <p:spPr>
            <a:xfrm>
              <a:off x="7663331" y="16155911"/>
              <a:ext cx="0" cy="2450121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Rectangle 18"/>
            <p:cNvSpPr/>
            <p:nvPr/>
          </p:nvSpPr>
          <p:spPr>
            <a:xfrm>
              <a:off x="4398755" y="14669574"/>
              <a:ext cx="553357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NmtR</a:t>
              </a:r>
              <a:endParaRPr lang="en-US" sz="1100" b="1" dirty="0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3766433" y="19335440"/>
              <a:ext cx="514885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zrA</a:t>
              </a:r>
              <a:endParaRPr lang="en-US" sz="1100" b="1" dirty="0"/>
            </a:p>
          </p:txBody>
        </p:sp>
        <p:sp>
          <p:nvSpPr>
            <p:cNvPr id="21" name="Rectangle 20"/>
            <p:cNvSpPr/>
            <p:nvPr/>
          </p:nvSpPr>
          <p:spPr>
            <a:xfrm>
              <a:off x="4418244" y="17955990"/>
              <a:ext cx="54213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rsR</a:t>
              </a:r>
              <a:r>
                <a:rPr lang="en-US" sz="11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endParaRPr lang="en-US" sz="1100" b="1" dirty="0"/>
            </a:p>
          </p:txBody>
        </p:sp>
        <p:sp>
          <p:nvSpPr>
            <p:cNvPr id="22" name="Rectangle 21"/>
            <p:cNvSpPr/>
            <p:nvPr/>
          </p:nvSpPr>
          <p:spPr>
            <a:xfrm>
              <a:off x="4428653" y="19507226"/>
              <a:ext cx="569387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BxmR</a:t>
              </a:r>
              <a:endParaRPr lang="en-US" sz="1100" b="1" dirty="0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3853783" y="19672223"/>
              <a:ext cx="49084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ZiaR</a:t>
              </a:r>
              <a:endParaRPr lang="en-US" sz="1100" b="1" dirty="0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4491292" y="19844857"/>
              <a:ext cx="521297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tB</a:t>
              </a:r>
              <a:endParaRPr lang="en-US" sz="1100" b="1" dirty="0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3908908" y="18132454"/>
              <a:ext cx="54213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rsR</a:t>
              </a:r>
              <a:r>
                <a:rPr lang="en-US" sz="11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endParaRPr lang="en-US" sz="1100" b="1" dirty="0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4703812" y="18820433"/>
              <a:ext cx="53893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dC</a:t>
              </a:r>
              <a:endParaRPr lang="en-US" sz="1100" b="1" dirty="0"/>
            </a:p>
          </p:txBody>
        </p:sp>
        <p:sp>
          <p:nvSpPr>
            <p:cNvPr id="27" name="Rectangle 26"/>
            <p:cNvSpPr/>
            <p:nvPr/>
          </p:nvSpPr>
          <p:spPr>
            <a:xfrm>
              <a:off x="4832148" y="18984865"/>
              <a:ext cx="53893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dC</a:t>
              </a:r>
              <a:endParaRPr lang="en-US" sz="1100" b="1" dirty="0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4535432" y="5257929"/>
              <a:ext cx="566181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b</a:t>
              </a:r>
              <a:r>
                <a:rPr lang="en-US" sz="11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Cd</a:t>
              </a:r>
              <a:endParaRPr lang="en-US" sz="1100" b="1" dirty="0"/>
            </a:p>
          </p:txBody>
        </p:sp>
        <p:sp>
          <p:nvSpPr>
            <p:cNvPr id="29" name="Rectangle 28"/>
            <p:cNvSpPr/>
            <p:nvPr/>
          </p:nvSpPr>
          <p:spPr>
            <a:xfrm>
              <a:off x="4418244" y="5434881"/>
              <a:ext cx="32573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Ni</a:t>
              </a:r>
              <a:endParaRPr lang="en-US" sz="1100" b="1" dirty="0"/>
            </a:p>
          </p:txBody>
        </p:sp>
        <p:sp>
          <p:nvSpPr>
            <p:cNvPr id="30" name="Rectangle 29"/>
            <p:cNvSpPr/>
            <p:nvPr/>
          </p:nvSpPr>
          <p:spPr>
            <a:xfrm>
              <a:off x="5047807" y="8018895"/>
              <a:ext cx="36580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3845204" y="10576575"/>
              <a:ext cx="36580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31"/>
            <p:cNvSpPr/>
            <p:nvPr/>
          </p:nvSpPr>
          <p:spPr>
            <a:xfrm>
              <a:off x="3859837" y="12294415"/>
              <a:ext cx="78899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e Co </a:t>
              </a:r>
              <a:r>
                <a:rPr lang="en-US" sz="11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n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32"/>
            <p:cNvSpPr/>
            <p:nvPr/>
          </p:nvSpPr>
          <p:spPr>
            <a:xfrm>
              <a:off x="4335834" y="11964702"/>
              <a:ext cx="36580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ctangle 33"/>
            <p:cNvSpPr/>
            <p:nvPr/>
          </p:nvSpPr>
          <p:spPr>
            <a:xfrm>
              <a:off x="3591545" y="12641060"/>
              <a:ext cx="36580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34"/>
            <p:cNvSpPr/>
            <p:nvPr/>
          </p:nvSpPr>
          <p:spPr>
            <a:xfrm>
              <a:off x="4225088" y="12130509"/>
              <a:ext cx="36580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3691458" y="12480879"/>
              <a:ext cx="36580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4583475" y="11795887"/>
              <a:ext cx="1143262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pt-BR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 As Zn Pb Se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ctangle 37"/>
            <p:cNvSpPr/>
            <p:nvPr/>
          </p:nvSpPr>
          <p:spPr>
            <a:xfrm>
              <a:off x="3740639" y="15557518"/>
              <a:ext cx="36580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u</a:t>
              </a:r>
              <a:endParaRPr lang="en-US" sz="1100" b="1" dirty="0"/>
            </a:p>
          </p:txBody>
        </p:sp>
        <p:sp>
          <p:nvSpPr>
            <p:cNvPr id="39" name="Rectangle 38"/>
            <p:cNvSpPr/>
            <p:nvPr/>
          </p:nvSpPr>
          <p:spPr>
            <a:xfrm>
              <a:off x="3711945" y="15723106"/>
              <a:ext cx="78899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e </a:t>
              </a:r>
              <a:r>
                <a:rPr lang="en-US" sz="1100" b="1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n</a:t>
              </a:r>
              <a:r>
                <a:rPr lang="en-US" sz="11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Co</a:t>
              </a:r>
              <a:endParaRPr lang="en-US" sz="1100" b="1" dirty="0"/>
            </a:p>
          </p:txBody>
        </p:sp>
        <p:sp>
          <p:nvSpPr>
            <p:cNvPr id="40" name="Rectangle 39"/>
            <p:cNvSpPr/>
            <p:nvPr/>
          </p:nvSpPr>
          <p:spPr>
            <a:xfrm>
              <a:off x="3945161" y="15894301"/>
              <a:ext cx="32573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e</a:t>
              </a:r>
              <a:endParaRPr lang="en-US" sz="1100" b="1" dirty="0"/>
            </a:p>
          </p:txBody>
        </p:sp>
        <p:sp>
          <p:nvSpPr>
            <p:cNvPr id="42" name="Rectangle 41"/>
            <p:cNvSpPr/>
            <p:nvPr/>
          </p:nvSpPr>
          <p:spPr>
            <a:xfrm>
              <a:off x="7713287" y="1637954"/>
              <a:ext cx="116249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uncharacterized</a:t>
              </a:r>
              <a:endParaRPr lang="en-US" sz="1100" b="1" dirty="0"/>
            </a:p>
          </p:txBody>
        </p:sp>
        <p:cxnSp>
          <p:nvCxnSpPr>
            <p:cNvPr id="43" name="Straight Connector 42"/>
            <p:cNvCxnSpPr/>
            <p:nvPr/>
          </p:nvCxnSpPr>
          <p:spPr>
            <a:xfrm>
              <a:off x="7663331" y="-482077"/>
              <a:ext cx="0" cy="4501672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Rectangle 43"/>
            <p:cNvSpPr/>
            <p:nvPr/>
          </p:nvSpPr>
          <p:spPr>
            <a:xfrm>
              <a:off x="7743756" y="13966789"/>
              <a:ext cx="817853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NmtR</a:t>
              </a:r>
              <a:r>
                <a:rPr lang="en-US" sz="11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like</a:t>
              </a:r>
              <a:endParaRPr lang="en-US" sz="1100" b="1" dirty="0"/>
            </a:p>
          </p:txBody>
        </p:sp>
        <p:cxnSp>
          <p:nvCxnSpPr>
            <p:cNvPr id="45" name="Straight Connector 44"/>
            <p:cNvCxnSpPr/>
            <p:nvPr/>
          </p:nvCxnSpPr>
          <p:spPr>
            <a:xfrm>
              <a:off x="7663331" y="12853290"/>
              <a:ext cx="0" cy="2450121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Rectangle 47"/>
            <p:cNvSpPr/>
            <p:nvPr/>
          </p:nvSpPr>
          <p:spPr>
            <a:xfrm>
              <a:off x="4013491" y="18290409"/>
              <a:ext cx="78899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e </a:t>
              </a:r>
              <a:r>
                <a:rPr lang="en-US" sz="1100" b="1" dirty="0" err="1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n</a:t>
              </a:r>
              <a:r>
                <a:rPr lang="en-US" sz="11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Co</a:t>
              </a:r>
              <a:endParaRPr lang="en-US" sz="1100" b="1" dirty="0"/>
            </a:p>
          </p:txBody>
        </p:sp>
        <p:sp>
          <p:nvSpPr>
            <p:cNvPr id="49" name="Rectangle 48"/>
            <p:cNvSpPr/>
            <p:nvPr/>
          </p:nvSpPr>
          <p:spPr>
            <a:xfrm>
              <a:off x="4039584" y="18463545"/>
              <a:ext cx="36580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u</a:t>
              </a:r>
              <a:endParaRPr lang="en-US" sz="1100" b="1" dirty="0"/>
            </a:p>
          </p:txBody>
        </p:sp>
        <p:sp>
          <p:nvSpPr>
            <p:cNvPr id="50" name="Rectangle 49"/>
            <p:cNvSpPr/>
            <p:nvPr/>
          </p:nvSpPr>
          <p:spPr>
            <a:xfrm>
              <a:off x="3520712" y="18645605"/>
              <a:ext cx="34977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r</a:t>
              </a:r>
              <a:endParaRPr lang="en-US" sz="1100" b="1" dirty="0"/>
            </a:p>
          </p:txBody>
        </p:sp>
        <p:sp>
          <p:nvSpPr>
            <p:cNvPr id="51" name="Rectangle 50"/>
            <p:cNvSpPr/>
            <p:nvPr/>
          </p:nvSpPr>
          <p:spPr>
            <a:xfrm>
              <a:off x="3964995" y="19169595"/>
              <a:ext cx="1367682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1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s Cd Ag Zn Cu Ni</a:t>
              </a:r>
              <a:endParaRPr lang="en-US" sz="11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2058477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3</TotalTime>
  <Words>49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al Furnholm</dc:creator>
  <cp:lastModifiedBy>Teal Furnholm</cp:lastModifiedBy>
  <cp:revision>21</cp:revision>
  <dcterms:created xsi:type="dcterms:W3CDTF">2014-10-31T05:32:35Z</dcterms:created>
  <dcterms:modified xsi:type="dcterms:W3CDTF">2014-11-03T06:19:33Z</dcterms:modified>
</cp:coreProperties>
</file>